
<file path=[Content_Types].xml><?xml version="1.0" encoding="utf-8"?>
<Types xmlns="http://schemas.openxmlformats.org/package/2006/content-types">
  <Default Extension="xml" ContentType="application/xml"/>
  <Default Extension="mp4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51" r:id="rId2"/>
    <p:sldId id="349" r:id="rId3"/>
    <p:sldId id="34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625" autoAdjust="0"/>
    <p:restoredTop sz="95433" autoAdjust="0"/>
  </p:normalViewPr>
  <p:slideViewPr>
    <p:cSldViewPr snapToGrid="0" snapToObjects="1">
      <p:cViewPr>
        <p:scale>
          <a:sx n="100" d="100"/>
          <a:sy n="100" d="100"/>
        </p:scale>
        <p:origin x="-1560" y="-73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C7E7DF-364E-6348-8F00-651710909A68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68283-521D-A149-BB4E-888A92336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2656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413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542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76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978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679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996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840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611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371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980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60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DB87B-556B-0340-A710-FC72D69C209A}" type="datetimeFigureOut">
              <a:rPr lang="en-US" smtClean="0"/>
              <a:t>15/0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603AD-E3D4-B749-95F5-9DC9C1414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597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png"/><Relationship Id="rId5" Type="http://schemas.openxmlformats.org/officeDocument/2006/relationships/image" Target="../media/image3.png"/><Relationship Id="rId1" Type="http://schemas.microsoft.com/office/2007/relationships/media" Target="../media/media2.mp4"/><Relationship Id="rId2" Type="http://schemas.openxmlformats.org/officeDocument/2006/relationships/video" Target="../media/media2.mp4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png"/><Relationship Id="rId5" Type="http://schemas.openxmlformats.org/officeDocument/2006/relationships/image" Target="../media/image4.png"/><Relationship Id="rId1" Type="http://schemas.microsoft.com/office/2007/relationships/media" Target="../media/media3.mp4"/><Relationship Id="rId2" Type="http://schemas.openxmlformats.org/officeDocument/2006/relationships/video" Target="../media/media3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tacts_sidebyside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14400" y="1195386"/>
            <a:ext cx="8204200" cy="46148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7200" y="152400"/>
            <a:ext cx="66073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actile activity in animals without regeneration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82800" y="5842000"/>
            <a:ext cx="1117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ol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58000" y="5842000"/>
            <a:ext cx="573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HU</a:t>
            </a:r>
            <a:endParaRPr lang="en-US" sz="2400" dirty="0">
              <a:solidFill>
                <a:schemeClr val="bg1"/>
              </a:solidFill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5002467" y="889000"/>
            <a:ext cx="15367" cy="5969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Untitled-2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9018"/>
            <a:ext cx="1185463" cy="19029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65042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49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par>
              <p:cTn id="7"/>
            </p:par>
            <p:par>
              <p:cTn id="8"/>
            </p:par>
            <p:par>
              <p:cTn id="9"/>
            </p:par>
            <p:par>
              <p:cTn id="10"/>
            </p:par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6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Head_reg_sidebyside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82324" y="1346200"/>
            <a:ext cx="8048976" cy="452754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7200" y="152400"/>
            <a:ext cx="83082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actile activity in animals having regenerated their apical half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11300" y="5842000"/>
            <a:ext cx="28787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ol  regeneration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715000" y="5842000"/>
            <a:ext cx="23365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HU  regeneration</a:t>
            </a:r>
            <a:endParaRPr lang="en-US" sz="2400" dirty="0">
              <a:solidFill>
                <a:schemeClr val="bg1"/>
              </a:solidFill>
            </a:endParaRPr>
          </a:p>
        </p:txBody>
      </p:sp>
      <p:pic>
        <p:nvPicPr>
          <p:cNvPr id="10" name="Picture 9" descr="head_reg_figurine_whit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9018"/>
            <a:ext cx="1216660" cy="1902981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5116767" y="889000"/>
            <a:ext cx="15367" cy="5969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98612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49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par>
              <p:cTn id="7"/>
            </p:par>
            <p:par>
              <p:cTn id="8"/>
            </p:par>
            <p:par>
              <p:cTn id="9"/>
            </p:par>
            <p:par>
              <p:cTn id="10"/>
            </p:par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6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Foot_reg_sidebyside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55321" y="1358900"/>
            <a:ext cx="8252178" cy="464185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7200" y="152400"/>
            <a:ext cx="82985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actile activity in animals having regenerated their basal half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11300" y="5842000"/>
            <a:ext cx="28787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Control  regeneration</a:t>
            </a:r>
            <a:endParaRPr lang="en-US" sz="2400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715000" y="5842000"/>
            <a:ext cx="23365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/>
                </a:solidFill>
              </a:rPr>
              <a:t>HU  regeneration</a:t>
            </a:r>
            <a:endParaRPr lang="en-US" sz="2400" dirty="0">
              <a:solidFill>
                <a:schemeClr val="bg1"/>
              </a:solidFill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5091367" y="889000"/>
            <a:ext cx="15367" cy="5969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Picture 7" descr="foot_reg_figurine_whit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9018"/>
            <a:ext cx="1176020" cy="18878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7392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49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par>
              <p:cTn id="7"/>
            </p:par>
            <p:par>
              <p:cTn id="8"/>
            </p:par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4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3</TotalTime>
  <Words>34</Words>
  <Application>Microsoft Macintosh PowerPoint</Application>
  <PresentationFormat>On-screen Show (4:3)</PresentationFormat>
  <Paragraphs>9</Paragraphs>
  <Slides>3</Slides>
  <Notes>0</Notes>
  <HiddenSlides>0</HiddenSlides>
  <MMClips>3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van Wenger</dc:creator>
  <cp:lastModifiedBy>Yvan W</cp:lastModifiedBy>
  <cp:revision>260</cp:revision>
  <dcterms:created xsi:type="dcterms:W3CDTF">2015-03-05T18:14:16Z</dcterms:created>
  <dcterms:modified xsi:type="dcterms:W3CDTF">2015-08-14T23:32:45Z</dcterms:modified>
</cp:coreProperties>
</file>